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57" r:id="rId3"/>
    <p:sldId id="258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419" autoAdjust="0"/>
    <p:restoredTop sz="94660"/>
  </p:normalViewPr>
  <p:slideViewPr>
    <p:cSldViewPr snapToGrid="0" showGuides="1">
      <p:cViewPr>
        <p:scale>
          <a:sx n="104" d="100"/>
          <a:sy n="104" d="100"/>
        </p:scale>
        <p:origin x="-312" y="456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9/5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tags" Target="../tags/tag66.xml"/><Relationship Id="rId7" Type="http://schemas.openxmlformats.org/officeDocument/2006/relationships/image" Target="../media/image3.png"/><Relationship Id="rId2" Type="http://schemas.openxmlformats.org/officeDocument/2006/relationships/tags" Target="../tags/tag65.xml"/><Relationship Id="rId1" Type="http://schemas.openxmlformats.org/officeDocument/2006/relationships/tags" Target="../tags/tag64.xml"/><Relationship Id="rId6" Type="http://schemas.openxmlformats.org/officeDocument/2006/relationships/image" Target="../media/image2.png"/><Relationship Id="rId5" Type="http://schemas.openxmlformats.org/officeDocument/2006/relationships/slideLayout" Target="../slideLayouts/slideLayout2.xml"/><Relationship Id="rId4" Type="http://schemas.openxmlformats.org/officeDocument/2006/relationships/tags" Target="../tags/tag6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1(4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3505" y="664845"/>
            <a:ext cx="9144000" cy="36576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490345" y="4778375"/>
            <a:ext cx="9026525" cy="4298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1.</a:t>
            </a:r>
            <a:r>
              <a:rPr lang="en-US" altLang="zh-CN" sz="2200">
                <a:latin typeface="Times New Roman" panose="02020603050405020304" charset="0"/>
                <a:cs typeface="Times New Roman" panose="02020603050405020304" charset="0"/>
              </a:rPr>
              <a:t>The continuous variable distribution of different IUBP duration.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1840865" y="960755"/>
            <a:ext cx="2042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ilcoxon,P=0.171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4804410" y="960755"/>
            <a:ext cx="2056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ilcoxon,P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＜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0.001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8460740" y="960755"/>
            <a:ext cx="2056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ilcoxon,P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＜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0.001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489710" y="4015740"/>
            <a:ext cx="7753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IUBP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322070" y="664845"/>
            <a:ext cx="8001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Years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4424045" y="655320"/>
            <a:ext cx="623570" cy="3162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mm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7399655" y="655320"/>
            <a:ext cx="522605" cy="3162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mm</a:t>
            </a: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碗里的食物&#10;&#10;AI 生成的内容可能不正确。">
            <a:extLst>
              <a:ext uri="{FF2B5EF4-FFF2-40B4-BE49-F238E27FC236}">
                <a16:creationId xmlns:a16="http://schemas.microsoft.com/office/drawing/2014/main" id="{8093B70F-A3BA-E861-DCE9-527C37F030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62252" y="1625918"/>
            <a:ext cx="1791569" cy="1800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16025" y="4270375"/>
            <a:ext cx="9759888" cy="157899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2. Hysteroscopic pictures of endometrium polyp</a:t>
            </a:r>
          </a:p>
          <a:p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. Polyps before surgery; B. After the polyps were removed by suction and curettage, there were still some unnoticeable polyps root tissue at the wall;  C. Poly recurrence with LNG-IUS placement.</a:t>
            </a:r>
          </a:p>
        </p:txBody>
      </p:sp>
      <p:pic>
        <p:nvPicPr>
          <p:cNvPr id="13" name="图片 4"/>
          <p:cNvPicPr>
            <a:picLocks noChangeAspect="1"/>
          </p:cNvPicPr>
          <p:nvPr/>
        </p:nvPicPr>
        <p:blipFill>
          <a:blip r:embed="rId7"/>
          <a:srcRect l="408" t="2689" r="10449" b="6252"/>
          <a:stretch>
            <a:fillRect/>
          </a:stretch>
        </p:blipFill>
        <p:spPr>
          <a:xfrm>
            <a:off x="1621267" y="1625918"/>
            <a:ext cx="1808254" cy="1800000"/>
          </a:xfrm>
          <a:prstGeom prst="ellipse">
            <a:avLst/>
          </a:prstGeom>
          <a:noFill/>
          <a:ln w="9525">
            <a:noFill/>
          </a:ln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28" name="图片 5"/>
          <p:cNvPicPr>
            <a:picLocks noChangeAspect="1"/>
          </p:cNvPicPr>
          <p:nvPr/>
        </p:nvPicPr>
        <p:blipFill>
          <a:blip r:embed="rId8"/>
          <a:srcRect l="1553" t="2392" r="12056" b="10099"/>
          <a:stretch>
            <a:fillRect/>
          </a:stretch>
        </p:blipFill>
        <p:spPr>
          <a:xfrm>
            <a:off x="5183823" y="1625918"/>
            <a:ext cx="1824127" cy="1800000"/>
          </a:xfrm>
          <a:prstGeom prst="ellipse">
            <a:avLst/>
          </a:prstGeom>
          <a:noFill/>
          <a:ln w="9525">
            <a:noFill/>
          </a:ln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5012690" y="1628775"/>
            <a:ext cx="5410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8762569" y="1626235"/>
            <a:ext cx="412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</a:p>
        </p:txBody>
      </p:sp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1404097" y="1753870"/>
            <a:ext cx="5251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7441565" y="1628775"/>
            <a:ext cx="499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endParaRPr lang="en-US" altLang="zh-CN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8585" y="887730"/>
            <a:ext cx="6616065" cy="409257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63320" y="4980305"/>
            <a:ext cx="958659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3.After i</a:t>
            </a:r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</a:rPr>
              <a:t>ntroducing the interaction term of the significant variables,  the interaction term was not shown to be significant (P=0.533), the overall calib</a:t>
            </a:r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ation showed limited improvement</a:t>
            </a:r>
            <a:endParaRPr lang="en-US" altLang="zh-CN" sz="2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1655" y="356235"/>
            <a:ext cx="6591935" cy="407733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343025" y="4755515"/>
            <a:ext cx="8632190" cy="7588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2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4.The Comparison of Models Performance with 95% confidence intervals by bootstrap approach.</a:t>
            </a:r>
          </a:p>
          <a:p>
            <a:endParaRPr lang="en-US" altLang="zh-CN" sz="2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表格&#10;&#10;AI 生成的内容可能不正确。">
            <a:extLst>
              <a:ext uri="{FF2B5EF4-FFF2-40B4-BE49-F238E27FC236}">
                <a16:creationId xmlns:a16="http://schemas.microsoft.com/office/drawing/2014/main" id="{4249F7AA-FC28-D568-9D44-B702B4F94F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2538" y="110169"/>
            <a:ext cx="7772400" cy="600594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13F897C-00D7-C905-3B26-98F83E9537B7}"/>
              </a:ext>
            </a:extLst>
          </p:cNvPr>
          <p:cNvSpPr txBox="1"/>
          <p:nvPr/>
        </p:nvSpPr>
        <p:spPr>
          <a:xfrm>
            <a:off x="231353" y="6211669"/>
            <a:ext cx="89144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5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Pictorial Blood Assessment Chart.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" altLang="zh-CN" dirty="0">
                <a:latin typeface="Times New Roman" panose="02020603050405020304" charset="0"/>
                <a:cs typeface="Times New Roman" panose="02020603050405020304" charset="0"/>
              </a:rPr>
              <a:t>https://</a:t>
            </a:r>
            <a:r>
              <a:rPr lang="en" altLang="zh-CN" dirty="0" err="1">
                <a:latin typeface="Times New Roman" panose="02020603050405020304" charset="0"/>
                <a:cs typeface="Times New Roman" panose="02020603050405020304" charset="0"/>
              </a:rPr>
              <a:t>hemophiliafed.org</a:t>
            </a:r>
            <a:r>
              <a:rPr lang="en" altLang="zh-CN" dirty="0">
                <a:latin typeface="Times New Roman" panose="02020603050405020304" charset="0"/>
                <a:cs typeface="Times New Roman" panose="02020603050405020304" charset="0"/>
              </a:rPr>
              <a:t>/wp-content/uploads/2023/08/PBAC_Weekly_Revised_08.23.23.pdf</a:t>
            </a:r>
            <a:r>
              <a:rPr lang="zh-CN" altLang="zh-CN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540175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98.4251968503937,&quot;left&quot;:52.65,&quot;top&quot;:150.6,&quot;width&quot;:849.6590551181104}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98.4251968503937,&quot;left&quot;:52.65,&quot;top&quot;:150.6,&quot;width&quot;:849.6590551181104}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98.4251968503937,&quot;left&quot;:52.65,&quot;top&quot;:150.6,&quot;width&quot;:849.6590551181104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1</TotalTime>
  <Words>159</Words>
  <Application>Microsoft Macintosh PowerPoint</Application>
  <PresentationFormat>宽屏</PresentationFormat>
  <Paragraphs>1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Arial</vt:lpstr>
      <vt:lpstr>Times New Roman</vt:lpstr>
      <vt:lpstr>Wingding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赵瑞昆</cp:lastModifiedBy>
  <cp:revision>172</cp:revision>
  <dcterms:created xsi:type="dcterms:W3CDTF">2019-06-19T02:08:00Z</dcterms:created>
  <dcterms:modified xsi:type="dcterms:W3CDTF">2025-09-05T00:5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2714BC2042754196817988410A36725A</vt:lpwstr>
  </property>
</Properties>
</file>